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4"/>
  </p:notesMasterIdLst>
  <p:sldIdLst>
    <p:sldId id="271" r:id="rId2"/>
    <p:sldId id="286" r:id="rId3"/>
  </p:sldIdLst>
  <p:sldSz cx="8534400" cy="64008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378" autoAdjust="0"/>
    <p:restoredTop sz="84372" autoAdjust="0"/>
  </p:normalViewPr>
  <p:slideViewPr>
    <p:cSldViewPr snapToGrid="0">
      <p:cViewPr varScale="1">
        <p:scale>
          <a:sx n="90" d="100"/>
          <a:sy n="90" d="100"/>
        </p:scale>
        <p:origin x="612" y="84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30" d="100"/>
        <a:sy n="13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olucci, Wilson" userId="7900a54f-73ee-4327-b3a1-b5b4c6201e75" providerId="ADAL" clId="{A20ACDCB-A46C-4E41-BC5D-EA908C6CC53B}"/>
    <pc:docChg chg="delSld modSld">
      <pc:chgData name="Colucci, Wilson" userId="7900a54f-73ee-4327-b3a1-b5b4c6201e75" providerId="ADAL" clId="{A20ACDCB-A46C-4E41-BC5D-EA908C6CC53B}" dt="2025-03-27T17:09:54.796" v="1" actId="2696"/>
      <pc:docMkLst>
        <pc:docMk/>
      </pc:docMkLst>
      <pc:sldChg chg="del">
        <pc:chgData name="Colucci, Wilson" userId="7900a54f-73ee-4327-b3a1-b5b4c6201e75" providerId="ADAL" clId="{A20ACDCB-A46C-4E41-BC5D-EA908C6CC53B}" dt="2025-03-27T17:09:54.796" v="1" actId="2696"/>
        <pc:sldMkLst>
          <pc:docMk/>
          <pc:sldMk cId="1448540889" sldId="284"/>
        </pc:sldMkLst>
      </pc:sldChg>
      <pc:sldChg chg="modSp mod">
        <pc:chgData name="Colucci, Wilson" userId="7900a54f-73ee-4327-b3a1-b5b4c6201e75" providerId="ADAL" clId="{A20ACDCB-A46C-4E41-BC5D-EA908C6CC53B}" dt="2025-03-27T17:09:40.678" v="0" actId="115"/>
        <pc:sldMkLst>
          <pc:docMk/>
          <pc:sldMk cId="2584510801" sldId="286"/>
        </pc:sldMkLst>
        <pc:spChg chg="mod">
          <ac:chgData name="Colucci, Wilson" userId="7900a54f-73ee-4327-b3a1-b5b4c6201e75" providerId="ADAL" clId="{A20ACDCB-A46C-4E41-BC5D-EA908C6CC53B}" dt="2025-03-27T17:09:40.678" v="0" actId="115"/>
          <ac:spMkLst>
            <pc:docMk/>
            <pc:sldMk cId="2584510801" sldId="286"/>
            <ac:spMk id="3" creationId="{2E0774AE-8898-6201-4C0A-AAEAB1C60D01}"/>
          </ac:spMkLst>
        </pc:spChg>
      </pc:sldChg>
    </pc:docChg>
  </pc:docChgLst>
  <pc:docChgLst>
    <pc:chgData name="Colucci, Wilson" userId="7900a54f-73ee-4327-b3a1-b5b4c6201e75" providerId="ADAL" clId="{09014972-0E74-4008-8E1D-C01A68E81AF4}"/>
    <pc:docChg chg="delSld">
      <pc:chgData name="Colucci, Wilson" userId="7900a54f-73ee-4327-b3a1-b5b4c6201e75" providerId="ADAL" clId="{09014972-0E74-4008-8E1D-C01A68E81AF4}" dt="2025-01-21T22:16:33.305" v="1" actId="2696"/>
      <pc:docMkLst>
        <pc:docMk/>
      </pc:docMkLst>
      <pc:sldChg chg="del">
        <pc:chgData name="Colucci, Wilson" userId="7900a54f-73ee-4327-b3a1-b5b4c6201e75" providerId="ADAL" clId="{09014972-0E74-4008-8E1D-C01A68E81AF4}" dt="2025-01-21T22:16:24.579" v="0" actId="2696"/>
        <pc:sldMkLst>
          <pc:docMk/>
          <pc:sldMk cId="1869718541" sldId="258"/>
        </pc:sldMkLst>
      </pc:sldChg>
      <pc:sldChg chg="del">
        <pc:chgData name="Colucci, Wilson" userId="7900a54f-73ee-4327-b3a1-b5b4c6201e75" providerId="ADAL" clId="{09014972-0E74-4008-8E1D-C01A68E81AF4}" dt="2025-01-21T22:16:24.579" v="0" actId="2696"/>
        <pc:sldMkLst>
          <pc:docMk/>
          <pc:sldMk cId="1019242640" sldId="262"/>
        </pc:sldMkLst>
      </pc:sldChg>
      <pc:sldChg chg="del">
        <pc:chgData name="Colucci, Wilson" userId="7900a54f-73ee-4327-b3a1-b5b4c6201e75" providerId="ADAL" clId="{09014972-0E74-4008-8E1D-C01A68E81AF4}" dt="2025-01-21T22:16:24.579" v="0" actId="2696"/>
        <pc:sldMkLst>
          <pc:docMk/>
          <pc:sldMk cId="440070150" sldId="263"/>
        </pc:sldMkLst>
      </pc:sldChg>
      <pc:sldChg chg="del">
        <pc:chgData name="Colucci, Wilson" userId="7900a54f-73ee-4327-b3a1-b5b4c6201e75" providerId="ADAL" clId="{09014972-0E74-4008-8E1D-C01A68E81AF4}" dt="2025-01-21T22:16:24.579" v="0" actId="2696"/>
        <pc:sldMkLst>
          <pc:docMk/>
          <pc:sldMk cId="4208362480" sldId="266"/>
        </pc:sldMkLst>
      </pc:sldChg>
      <pc:sldChg chg="del">
        <pc:chgData name="Colucci, Wilson" userId="7900a54f-73ee-4327-b3a1-b5b4c6201e75" providerId="ADAL" clId="{09014972-0E74-4008-8E1D-C01A68E81AF4}" dt="2025-01-21T22:16:24.579" v="0" actId="2696"/>
        <pc:sldMkLst>
          <pc:docMk/>
          <pc:sldMk cId="1447749968" sldId="277"/>
        </pc:sldMkLst>
      </pc:sldChg>
      <pc:sldChg chg="del">
        <pc:chgData name="Colucci, Wilson" userId="7900a54f-73ee-4327-b3a1-b5b4c6201e75" providerId="ADAL" clId="{09014972-0E74-4008-8E1D-C01A68E81AF4}" dt="2025-01-21T22:16:24.579" v="0" actId="2696"/>
        <pc:sldMkLst>
          <pc:docMk/>
          <pc:sldMk cId="307524440" sldId="279"/>
        </pc:sldMkLst>
      </pc:sldChg>
      <pc:sldChg chg="del">
        <pc:chgData name="Colucci, Wilson" userId="7900a54f-73ee-4327-b3a1-b5b4c6201e75" providerId="ADAL" clId="{09014972-0E74-4008-8E1D-C01A68E81AF4}" dt="2025-01-21T22:16:24.579" v="0" actId="2696"/>
        <pc:sldMkLst>
          <pc:docMk/>
          <pc:sldMk cId="3316206793" sldId="282"/>
        </pc:sldMkLst>
      </pc:sldChg>
      <pc:sldChg chg="del">
        <pc:chgData name="Colucci, Wilson" userId="7900a54f-73ee-4327-b3a1-b5b4c6201e75" providerId="ADAL" clId="{09014972-0E74-4008-8E1D-C01A68E81AF4}" dt="2025-01-21T22:16:24.579" v="0" actId="2696"/>
        <pc:sldMkLst>
          <pc:docMk/>
          <pc:sldMk cId="2670409142" sldId="285"/>
        </pc:sldMkLst>
      </pc:sldChg>
      <pc:sldChg chg="del">
        <pc:chgData name="Colucci, Wilson" userId="7900a54f-73ee-4327-b3a1-b5b4c6201e75" providerId="ADAL" clId="{09014972-0E74-4008-8E1D-C01A68E81AF4}" dt="2025-01-21T22:16:24.579" v="0" actId="2696"/>
        <pc:sldMkLst>
          <pc:docMk/>
          <pc:sldMk cId="1305646959" sldId="291"/>
        </pc:sldMkLst>
      </pc:sldChg>
      <pc:sldChg chg="del">
        <pc:chgData name="Colucci, Wilson" userId="7900a54f-73ee-4327-b3a1-b5b4c6201e75" providerId="ADAL" clId="{09014972-0E74-4008-8E1D-C01A68E81AF4}" dt="2025-01-21T22:16:24.579" v="0" actId="2696"/>
        <pc:sldMkLst>
          <pc:docMk/>
          <pc:sldMk cId="637250390" sldId="292"/>
        </pc:sldMkLst>
      </pc:sldChg>
      <pc:sldChg chg="del">
        <pc:chgData name="Colucci, Wilson" userId="7900a54f-73ee-4327-b3a1-b5b4c6201e75" providerId="ADAL" clId="{09014972-0E74-4008-8E1D-C01A68E81AF4}" dt="2025-01-21T22:16:33.305" v="1" actId="2696"/>
        <pc:sldMkLst>
          <pc:docMk/>
          <pc:sldMk cId="2196638748" sldId="293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6AE3CD6D-9C41-439E-9769-8289668BD63E}" type="datetimeFigureOut">
              <a:rPr lang="en-US" smtClean="0"/>
              <a:t>3/27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14463" y="1162050"/>
            <a:ext cx="41814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803BD334-6DDB-4962-B38E-5B065E53ED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01973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25886" rtl="0" eaLnBrk="1" latinLnBrk="0" hangingPunct="1">
      <a:defRPr sz="1084" kern="1200">
        <a:solidFill>
          <a:schemeClr val="tx1"/>
        </a:solidFill>
        <a:latin typeface="+mn-lt"/>
        <a:ea typeface="+mn-ea"/>
        <a:cs typeface="+mn-cs"/>
      </a:defRPr>
    </a:lvl1pPr>
    <a:lvl2pPr marL="412943" algn="l" defTabSz="825886" rtl="0" eaLnBrk="1" latinLnBrk="0" hangingPunct="1">
      <a:defRPr sz="1084" kern="1200">
        <a:solidFill>
          <a:schemeClr val="tx1"/>
        </a:solidFill>
        <a:latin typeface="+mn-lt"/>
        <a:ea typeface="+mn-ea"/>
        <a:cs typeface="+mn-cs"/>
      </a:defRPr>
    </a:lvl2pPr>
    <a:lvl3pPr marL="825886" algn="l" defTabSz="825886" rtl="0" eaLnBrk="1" latinLnBrk="0" hangingPunct="1">
      <a:defRPr sz="1084" kern="1200">
        <a:solidFill>
          <a:schemeClr val="tx1"/>
        </a:solidFill>
        <a:latin typeface="+mn-lt"/>
        <a:ea typeface="+mn-ea"/>
        <a:cs typeface="+mn-cs"/>
      </a:defRPr>
    </a:lvl3pPr>
    <a:lvl4pPr marL="1238829" algn="l" defTabSz="825886" rtl="0" eaLnBrk="1" latinLnBrk="0" hangingPunct="1">
      <a:defRPr sz="1084" kern="1200">
        <a:solidFill>
          <a:schemeClr val="tx1"/>
        </a:solidFill>
        <a:latin typeface="+mn-lt"/>
        <a:ea typeface="+mn-ea"/>
        <a:cs typeface="+mn-cs"/>
      </a:defRPr>
    </a:lvl4pPr>
    <a:lvl5pPr marL="1651772" algn="l" defTabSz="825886" rtl="0" eaLnBrk="1" latinLnBrk="0" hangingPunct="1">
      <a:defRPr sz="1084" kern="1200">
        <a:solidFill>
          <a:schemeClr val="tx1"/>
        </a:solidFill>
        <a:latin typeface="+mn-lt"/>
        <a:ea typeface="+mn-ea"/>
        <a:cs typeface="+mn-cs"/>
      </a:defRPr>
    </a:lvl5pPr>
    <a:lvl6pPr marL="2064715" algn="l" defTabSz="825886" rtl="0" eaLnBrk="1" latinLnBrk="0" hangingPunct="1">
      <a:defRPr sz="1084" kern="1200">
        <a:solidFill>
          <a:schemeClr val="tx1"/>
        </a:solidFill>
        <a:latin typeface="+mn-lt"/>
        <a:ea typeface="+mn-ea"/>
        <a:cs typeface="+mn-cs"/>
      </a:defRPr>
    </a:lvl6pPr>
    <a:lvl7pPr marL="2477658" algn="l" defTabSz="825886" rtl="0" eaLnBrk="1" latinLnBrk="0" hangingPunct="1">
      <a:defRPr sz="1084" kern="1200">
        <a:solidFill>
          <a:schemeClr val="tx1"/>
        </a:solidFill>
        <a:latin typeface="+mn-lt"/>
        <a:ea typeface="+mn-ea"/>
        <a:cs typeface="+mn-cs"/>
      </a:defRPr>
    </a:lvl7pPr>
    <a:lvl8pPr marL="2890601" algn="l" defTabSz="825886" rtl="0" eaLnBrk="1" latinLnBrk="0" hangingPunct="1">
      <a:defRPr sz="1084" kern="1200">
        <a:solidFill>
          <a:schemeClr val="tx1"/>
        </a:solidFill>
        <a:latin typeface="+mn-lt"/>
        <a:ea typeface="+mn-ea"/>
        <a:cs typeface="+mn-cs"/>
      </a:defRPr>
    </a:lvl8pPr>
    <a:lvl9pPr marL="3303544" algn="l" defTabSz="825886" rtl="0" eaLnBrk="1" latinLnBrk="0" hangingPunct="1">
      <a:defRPr sz="108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40080" y="1047539"/>
            <a:ext cx="7254240" cy="2228427"/>
          </a:xfrm>
        </p:spPr>
        <p:txBody>
          <a:bodyPr anchor="b"/>
          <a:lstStyle>
            <a:lvl1pPr algn="ctr">
              <a:defRPr sz="5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66800" y="3361902"/>
            <a:ext cx="6400800" cy="1545378"/>
          </a:xfrm>
        </p:spPr>
        <p:txBody>
          <a:bodyPr/>
          <a:lstStyle>
            <a:lvl1pPr marL="0" indent="0" algn="ctr">
              <a:buNone/>
              <a:defRPr sz="2240"/>
            </a:lvl1pPr>
            <a:lvl2pPr marL="426705" indent="0" algn="ctr">
              <a:buNone/>
              <a:defRPr sz="1867"/>
            </a:lvl2pPr>
            <a:lvl3pPr marL="853410" indent="0" algn="ctr">
              <a:buNone/>
              <a:defRPr sz="1680"/>
            </a:lvl3pPr>
            <a:lvl4pPr marL="1280114" indent="0" algn="ctr">
              <a:buNone/>
              <a:defRPr sz="1493"/>
            </a:lvl4pPr>
            <a:lvl5pPr marL="1706819" indent="0" algn="ctr">
              <a:buNone/>
              <a:defRPr sz="1493"/>
            </a:lvl5pPr>
            <a:lvl6pPr marL="2133524" indent="0" algn="ctr">
              <a:buNone/>
              <a:defRPr sz="1493"/>
            </a:lvl6pPr>
            <a:lvl7pPr marL="2560229" indent="0" algn="ctr">
              <a:buNone/>
              <a:defRPr sz="1493"/>
            </a:lvl7pPr>
            <a:lvl8pPr marL="2986933" indent="0" algn="ctr">
              <a:buNone/>
              <a:defRPr sz="1493"/>
            </a:lvl8pPr>
            <a:lvl9pPr marL="3413638" indent="0" algn="ctr">
              <a:buNone/>
              <a:defRPr sz="149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3/27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38084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3/27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337591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107430" y="340783"/>
            <a:ext cx="1840230" cy="542438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86740" y="340783"/>
            <a:ext cx="5414010" cy="5424382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3/27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092867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3/27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420167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2295" y="1595757"/>
            <a:ext cx="7360920" cy="2662555"/>
          </a:xfrm>
        </p:spPr>
        <p:txBody>
          <a:bodyPr anchor="b"/>
          <a:lstStyle>
            <a:lvl1pPr>
              <a:defRPr sz="5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82295" y="4283500"/>
            <a:ext cx="7360920" cy="1400175"/>
          </a:xfrm>
        </p:spPr>
        <p:txBody>
          <a:bodyPr/>
          <a:lstStyle>
            <a:lvl1pPr marL="0" indent="0">
              <a:buNone/>
              <a:defRPr sz="2240">
                <a:solidFill>
                  <a:schemeClr val="tx1"/>
                </a:solidFill>
              </a:defRPr>
            </a:lvl1pPr>
            <a:lvl2pPr marL="426705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2pPr>
            <a:lvl3pPr marL="85341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3pPr>
            <a:lvl4pPr marL="1280114" indent="0">
              <a:buNone/>
              <a:defRPr sz="1493">
                <a:solidFill>
                  <a:schemeClr val="tx1">
                    <a:tint val="75000"/>
                  </a:schemeClr>
                </a:solidFill>
              </a:defRPr>
            </a:lvl4pPr>
            <a:lvl5pPr marL="1706819" indent="0">
              <a:buNone/>
              <a:defRPr sz="1493">
                <a:solidFill>
                  <a:schemeClr val="tx1">
                    <a:tint val="75000"/>
                  </a:schemeClr>
                </a:solidFill>
              </a:defRPr>
            </a:lvl5pPr>
            <a:lvl6pPr marL="2133524" indent="0">
              <a:buNone/>
              <a:defRPr sz="1493">
                <a:solidFill>
                  <a:schemeClr val="tx1">
                    <a:tint val="75000"/>
                  </a:schemeClr>
                </a:solidFill>
              </a:defRPr>
            </a:lvl6pPr>
            <a:lvl7pPr marL="2560229" indent="0">
              <a:buNone/>
              <a:defRPr sz="1493">
                <a:solidFill>
                  <a:schemeClr val="tx1">
                    <a:tint val="75000"/>
                  </a:schemeClr>
                </a:solidFill>
              </a:defRPr>
            </a:lvl7pPr>
            <a:lvl8pPr marL="2986933" indent="0">
              <a:buNone/>
              <a:defRPr sz="1493">
                <a:solidFill>
                  <a:schemeClr val="tx1">
                    <a:tint val="75000"/>
                  </a:schemeClr>
                </a:solidFill>
              </a:defRPr>
            </a:lvl8pPr>
            <a:lvl9pPr marL="3413638" indent="0">
              <a:buNone/>
              <a:defRPr sz="149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3/27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08390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86740" y="1703917"/>
            <a:ext cx="3627120" cy="406124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20540" y="1703917"/>
            <a:ext cx="3627120" cy="406124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3/27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100199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7852" y="340785"/>
            <a:ext cx="7360920" cy="123719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87852" y="1569085"/>
            <a:ext cx="3610451" cy="768985"/>
          </a:xfrm>
        </p:spPr>
        <p:txBody>
          <a:bodyPr anchor="b"/>
          <a:lstStyle>
            <a:lvl1pPr marL="0" indent="0">
              <a:buNone/>
              <a:defRPr sz="2240" b="1"/>
            </a:lvl1pPr>
            <a:lvl2pPr marL="426705" indent="0">
              <a:buNone/>
              <a:defRPr sz="1867" b="1"/>
            </a:lvl2pPr>
            <a:lvl3pPr marL="853410" indent="0">
              <a:buNone/>
              <a:defRPr sz="1680" b="1"/>
            </a:lvl3pPr>
            <a:lvl4pPr marL="1280114" indent="0">
              <a:buNone/>
              <a:defRPr sz="1493" b="1"/>
            </a:lvl4pPr>
            <a:lvl5pPr marL="1706819" indent="0">
              <a:buNone/>
              <a:defRPr sz="1493" b="1"/>
            </a:lvl5pPr>
            <a:lvl6pPr marL="2133524" indent="0">
              <a:buNone/>
              <a:defRPr sz="1493" b="1"/>
            </a:lvl6pPr>
            <a:lvl7pPr marL="2560229" indent="0">
              <a:buNone/>
              <a:defRPr sz="1493" b="1"/>
            </a:lvl7pPr>
            <a:lvl8pPr marL="2986933" indent="0">
              <a:buNone/>
              <a:defRPr sz="1493" b="1"/>
            </a:lvl8pPr>
            <a:lvl9pPr marL="3413638" indent="0">
              <a:buNone/>
              <a:defRPr sz="149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87852" y="2338070"/>
            <a:ext cx="3610451" cy="343894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320540" y="1569085"/>
            <a:ext cx="3628232" cy="768985"/>
          </a:xfrm>
        </p:spPr>
        <p:txBody>
          <a:bodyPr anchor="b"/>
          <a:lstStyle>
            <a:lvl1pPr marL="0" indent="0">
              <a:buNone/>
              <a:defRPr sz="2240" b="1"/>
            </a:lvl1pPr>
            <a:lvl2pPr marL="426705" indent="0">
              <a:buNone/>
              <a:defRPr sz="1867" b="1"/>
            </a:lvl2pPr>
            <a:lvl3pPr marL="853410" indent="0">
              <a:buNone/>
              <a:defRPr sz="1680" b="1"/>
            </a:lvl3pPr>
            <a:lvl4pPr marL="1280114" indent="0">
              <a:buNone/>
              <a:defRPr sz="1493" b="1"/>
            </a:lvl4pPr>
            <a:lvl5pPr marL="1706819" indent="0">
              <a:buNone/>
              <a:defRPr sz="1493" b="1"/>
            </a:lvl5pPr>
            <a:lvl6pPr marL="2133524" indent="0">
              <a:buNone/>
              <a:defRPr sz="1493" b="1"/>
            </a:lvl6pPr>
            <a:lvl7pPr marL="2560229" indent="0">
              <a:buNone/>
              <a:defRPr sz="1493" b="1"/>
            </a:lvl7pPr>
            <a:lvl8pPr marL="2986933" indent="0">
              <a:buNone/>
              <a:defRPr sz="1493" b="1"/>
            </a:lvl8pPr>
            <a:lvl9pPr marL="3413638" indent="0">
              <a:buNone/>
              <a:defRPr sz="149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320540" y="2338070"/>
            <a:ext cx="3628232" cy="343894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3/27/2025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444038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3/27/2025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314320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3/27/2025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379629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7852" y="426720"/>
            <a:ext cx="2752566" cy="1493520"/>
          </a:xfrm>
        </p:spPr>
        <p:txBody>
          <a:bodyPr anchor="b"/>
          <a:lstStyle>
            <a:lvl1pPr>
              <a:defRPr sz="298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628232" y="921598"/>
            <a:ext cx="4320540" cy="4548717"/>
          </a:xfrm>
        </p:spPr>
        <p:txBody>
          <a:bodyPr/>
          <a:lstStyle>
            <a:lvl1pPr>
              <a:defRPr sz="2987"/>
            </a:lvl1pPr>
            <a:lvl2pPr>
              <a:defRPr sz="2613"/>
            </a:lvl2pPr>
            <a:lvl3pPr>
              <a:defRPr sz="2240"/>
            </a:lvl3pPr>
            <a:lvl4pPr>
              <a:defRPr sz="1867"/>
            </a:lvl4pPr>
            <a:lvl5pPr>
              <a:defRPr sz="1867"/>
            </a:lvl5pPr>
            <a:lvl6pPr>
              <a:defRPr sz="1867"/>
            </a:lvl6pPr>
            <a:lvl7pPr>
              <a:defRPr sz="1867"/>
            </a:lvl7pPr>
            <a:lvl8pPr>
              <a:defRPr sz="1867"/>
            </a:lvl8pPr>
            <a:lvl9pPr>
              <a:defRPr sz="1867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87852" y="1920240"/>
            <a:ext cx="2752566" cy="3557482"/>
          </a:xfrm>
        </p:spPr>
        <p:txBody>
          <a:bodyPr/>
          <a:lstStyle>
            <a:lvl1pPr marL="0" indent="0">
              <a:buNone/>
              <a:defRPr sz="1493"/>
            </a:lvl1pPr>
            <a:lvl2pPr marL="426705" indent="0">
              <a:buNone/>
              <a:defRPr sz="1307"/>
            </a:lvl2pPr>
            <a:lvl3pPr marL="853410" indent="0">
              <a:buNone/>
              <a:defRPr sz="1120"/>
            </a:lvl3pPr>
            <a:lvl4pPr marL="1280114" indent="0">
              <a:buNone/>
              <a:defRPr sz="933"/>
            </a:lvl4pPr>
            <a:lvl5pPr marL="1706819" indent="0">
              <a:buNone/>
              <a:defRPr sz="933"/>
            </a:lvl5pPr>
            <a:lvl6pPr marL="2133524" indent="0">
              <a:buNone/>
              <a:defRPr sz="933"/>
            </a:lvl6pPr>
            <a:lvl7pPr marL="2560229" indent="0">
              <a:buNone/>
              <a:defRPr sz="933"/>
            </a:lvl7pPr>
            <a:lvl8pPr marL="2986933" indent="0">
              <a:buNone/>
              <a:defRPr sz="933"/>
            </a:lvl8pPr>
            <a:lvl9pPr marL="3413638" indent="0">
              <a:buNone/>
              <a:defRPr sz="9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3/27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250523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7852" y="426720"/>
            <a:ext cx="2752566" cy="1493520"/>
          </a:xfrm>
        </p:spPr>
        <p:txBody>
          <a:bodyPr anchor="b"/>
          <a:lstStyle>
            <a:lvl1pPr>
              <a:defRPr sz="298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628232" y="921598"/>
            <a:ext cx="4320540" cy="4548717"/>
          </a:xfrm>
        </p:spPr>
        <p:txBody>
          <a:bodyPr anchor="t"/>
          <a:lstStyle>
            <a:lvl1pPr marL="0" indent="0">
              <a:buNone/>
              <a:defRPr sz="2987"/>
            </a:lvl1pPr>
            <a:lvl2pPr marL="426705" indent="0">
              <a:buNone/>
              <a:defRPr sz="2613"/>
            </a:lvl2pPr>
            <a:lvl3pPr marL="853410" indent="0">
              <a:buNone/>
              <a:defRPr sz="2240"/>
            </a:lvl3pPr>
            <a:lvl4pPr marL="1280114" indent="0">
              <a:buNone/>
              <a:defRPr sz="1867"/>
            </a:lvl4pPr>
            <a:lvl5pPr marL="1706819" indent="0">
              <a:buNone/>
              <a:defRPr sz="1867"/>
            </a:lvl5pPr>
            <a:lvl6pPr marL="2133524" indent="0">
              <a:buNone/>
              <a:defRPr sz="1867"/>
            </a:lvl6pPr>
            <a:lvl7pPr marL="2560229" indent="0">
              <a:buNone/>
              <a:defRPr sz="1867"/>
            </a:lvl7pPr>
            <a:lvl8pPr marL="2986933" indent="0">
              <a:buNone/>
              <a:defRPr sz="1867"/>
            </a:lvl8pPr>
            <a:lvl9pPr marL="3413638" indent="0">
              <a:buNone/>
              <a:defRPr sz="18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87852" y="1920240"/>
            <a:ext cx="2752566" cy="3557482"/>
          </a:xfrm>
        </p:spPr>
        <p:txBody>
          <a:bodyPr/>
          <a:lstStyle>
            <a:lvl1pPr marL="0" indent="0">
              <a:buNone/>
              <a:defRPr sz="1493"/>
            </a:lvl1pPr>
            <a:lvl2pPr marL="426705" indent="0">
              <a:buNone/>
              <a:defRPr sz="1307"/>
            </a:lvl2pPr>
            <a:lvl3pPr marL="853410" indent="0">
              <a:buNone/>
              <a:defRPr sz="1120"/>
            </a:lvl3pPr>
            <a:lvl4pPr marL="1280114" indent="0">
              <a:buNone/>
              <a:defRPr sz="933"/>
            </a:lvl4pPr>
            <a:lvl5pPr marL="1706819" indent="0">
              <a:buNone/>
              <a:defRPr sz="933"/>
            </a:lvl5pPr>
            <a:lvl6pPr marL="2133524" indent="0">
              <a:buNone/>
              <a:defRPr sz="933"/>
            </a:lvl6pPr>
            <a:lvl7pPr marL="2560229" indent="0">
              <a:buNone/>
              <a:defRPr sz="933"/>
            </a:lvl7pPr>
            <a:lvl8pPr marL="2986933" indent="0">
              <a:buNone/>
              <a:defRPr sz="933"/>
            </a:lvl8pPr>
            <a:lvl9pPr marL="3413638" indent="0">
              <a:buNone/>
              <a:defRPr sz="9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3/27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875047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86740" y="340785"/>
            <a:ext cx="7360920" cy="12371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86740" y="1703917"/>
            <a:ext cx="7360920" cy="406124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86740" y="5932595"/>
            <a:ext cx="1920240" cy="3407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4DE79-268F-4C1A-8933-263129D2AF90}" type="datetimeFigureOut">
              <a:rPr lang="en-US" smtClean="0"/>
              <a:t>3/27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827020" y="5932595"/>
            <a:ext cx="2880360" cy="3407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027420" y="5932595"/>
            <a:ext cx="1920240" cy="3407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403700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853410" rtl="0" eaLnBrk="1" latinLnBrk="0" hangingPunct="1">
        <a:lnSpc>
          <a:spcPct val="90000"/>
        </a:lnSpc>
        <a:spcBef>
          <a:spcPct val="0"/>
        </a:spcBef>
        <a:buNone/>
        <a:defRPr sz="410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3352" indent="-213352" algn="l" defTabSz="853410" rtl="0" eaLnBrk="1" latinLnBrk="0" hangingPunct="1">
        <a:lnSpc>
          <a:spcPct val="90000"/>
        </a:lnSpc>
        <a:spcBef>
          <a:spcPts val="933"/>
        </a:spcBef>
        <a:buFont typeface="Arial" panose="020B0604020202020204" pitchFamily="34" charset="0"/>
        <a:buChar char="•"/>
        <a:defRPr sz="2613" kern="1200">
          <a:solidFill>
            <a:schemeClr val="tx1"/>
          </a:solidFill>
          <a:latin typeface="+mn-lt"/>
          <a:ea typeface="+mn-ea"/>
          <a:cs typeface="+mn-cs"/>
        </a:defRPr>
      </a:lvl1pPr>
      <a:lvl2pPr marL="640057" indent="-213352" algn="l" defTabSz="853410" rtl="0" eaLnBrk="1" latinLnBrk="0" hangingPunct="1">
        <a:lnSpc>
          <a:spcPct val="90000"/>
        </a:lnSpc>
        <a:spcBef>
          <a:spcPts val="467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2pPr>
      <a:lvl3pPr marL="1066762" indent="-213352" algn="l" defTabSz="853410" rtl="0" eaLnBrk="1" latinLnBrk="0" hangingPunct="1">
        <a:lnSpc>
          <a:spcPct val="90000"/>
        </a:lnSpc>
        <a:spcBef>
          <a:spcPts val="467"/>
        </a:spcBef>
        <a:buFont typeface="Arial" panose="020B0604020202020204" pitchFamily="34" charset="0"/>
        <a:buChar char="•"/>
        <a:defRPr sz="1867" kern="1200">
          <a:solidFill>
            <a:schemeClr val="tx1"/>
          </a:solidFill>
          <a:latin typeface="+mn-lt"/>
          <a:ea typeface="+mn-ea"/>
          <a:cs typeface="+mn-cs"/>
        </a:defRPr>
      </a:lvl3pPr>
      <a:lvl4pPr marL="1493467" indent="-213352" algn="l" defTabSz="853410" rtl="0" eaLnBrk="1" latinLnBrk="0" hangingPunct="1">
        <a:lnSpc>
          <a:spcPct val="90000"/>
        </a:lnSpc>
        <a:spcBef>
          <a:spcPts val="467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4pPr>
      <a:lvl5pPr marL="1920171" indent="-213352" algn="l" defTabSz="853410" rtl="0" eaLnBrk="1" latinLnBrk="0" hangingPunct="1">
        <a:lnSpc>
          <a:spcPct val="90000"/>
        </a:lnSpc>
        <a:spcBef>
          <a:spcPts val="467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5pPr>
      <a:lvl6pPr marL="2346876" indent="-213352" algn="l" defTabSz="853410" rtl="0" eaLnBrk="1" latinLnBrk="0" hangingPunct="1">
        <a:lnSpc>
          <a:spcPct val="90000"/>
        </a:lnSpc>
        <a:spcBef>
          <a:spcPts val="467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6pPr>
      <a:lvl7pPr marL="2773581" indent="-213352" algn="l" defTabSz="853410" rtl="0" eaLnBrk="1" latinLnBrk="0" hangingPunct="1">
        <a:lnSpc>
          <a:spcPct val="90000"/>
        </a:lnSpc>
        <a:spcBef>
          <a:spcPts val="467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86" indent="-213352" algn="l" defTabSz="853410" rtl="0" eaLnBrk="1" latinLnBrk="0" hangingPunct="1">
        <a:lnSpc>
          <a:spcPct val="90000"/>
        </a:lnSpc>
        <a:spcBef>
          <a:spcPts val="467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8pPr>
      <a:lvl9pPr marL="3626990" indent="-213352" algn="l" defTabSz="853410" rtl="0" eaLnBrk="1" latinLnBrk="0" hangingPunct="1">
        <a:lnSpc>
          <a:spcPct val="90000"/>
        </a:lnSpc>
        <a:spcBef>
          <a:spcPts val="467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53410" rtl="0" eaLnBrk="1" latinLnBrk="0" hangingPunct="1">
        <a:defRPr sz="1680" kern="1200">
          <a:solidFill>
            <a:schemeClr val="tx1"/>
          </a:solidFill>
          <a:latin typeface="+mn-lt"/>
          <a:ea typeface="+mn-ea"/>
          <a:cs typeface="+mn-cs"/>
        </a:defRPr>
      </a:lvl1pPr>
      <a:lvl2pPr marL="426705" algn="l" defTabSz="853410" rtl="0" eaLnBrk="1" latinLnBrk="0" hangingPunct="1">
        <a:defRPr sz="1680" kern="1200">
          <a:solidFill>
            <a:schemeClr val="tx1"/>
          </a:solidFill>
          <a:latin typeface="+mn-lt"/>
          <a:ea typeface="+mn-ea"/>
          <a:cs typeface="+mn-cs"/>
        </a:defRPr>
      </a:lvl2pPr>
      <a:lvl3pPr marL="853410" algn="l" defTabSz="853410" rtl="0" eaLnBrk="1" latinLnBrk="0" hangingPunct="1">
        <a:defRPr sz="168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14" algn="l" defTabSz="853410" rtl="0" eaLnBrk="1" latinLnBrk="0" hangingPunct="1">
        <a:defRPr sz="1680" kern="1200">
          <a:solidFill>
            <a:schemeClr val="tx1"/>
          </a:solidFill>
          <a:latin typeface="+mn-lt"/>
          <a:ea typeface="+mn-ea"/>
          <a:cs typeface="+mn-cs"/>
        </a:defRPr>
      </a:lvl4pPr>
      <a:lvl5pPr marL="1706819" algn="l" defTabSz="853410" rtl="0" eaLnBrk="1" latinLnBrk="0" hangingPunct="1">
        <a:defRPr sz="1680" kern="1200">
          <a:solidFill>
            <a:schemeClr val="tx1"/>
          </a:solidFill>
          <a:latin typeface="+mn-lt"/>
          <a:ea typeface="+mn-ea"/>
          <a:cs typeface="+mn-cs"/>
        </a:defRPr>
      </a:lvl5pPr>
      <a:lvl6pPr marL="2133524" algn="l" defTabSz="853410" rtl="0" eaLnBrk="1" latinLnBrk="0" hangingPunct="1">
        <a:defRPr sz="1680" kern="1200">
          <a:solidFill>
            <a:schemeClr val="tx1"/>
          </a:solidFill>
          <a:latin typeface="+mn-lt"/>
          <a:ea typeface="+mn-ea"/>
          <a:cs typeface="+mn-cs"/>
        </a:defRPr>
      </a:lvl6pPr>
      <a:lvl7pPr marL="2560229" algn="l" defTabSz="853410" rtl="0" eaLnBrk="1" latinLnBrk="0" hangingPunct="1">
        <a:defRPr sz="1680" kern="1200">
          <a:solidFill>
            <a:schemeClr val="tx1"/>
          </a:solidFill>
          <a:latin typeface="+mn-lt"/>
          <a:ea typeface="+mn-ea"/>
          <a:cs typeface="+mn-cs"/>
        </a:defRPr>
      </a:lvl7pPr>
      <a:lvl8pPr marL="2986933" algn="l" defTabSz="853410" rtl="0" eaLnBrk="1" latinLnBrk="0" hangingPunct="1">
        <a:defRPr sz="1680" kern="1200">
          <a:solidFill>
            <a:schemeClr val="tx1"/>
          </a:solidFill>
          <a:latin typeface="+mn-lt"/>
          <a:ea typeface="+mn-ea"/>
          <a:cs typeface="+mn-cs"/>
        </a:defRPr>
      </a:lvl8pPr>
      <a:lvl9pPr marL="3413638" algn="l" defTabSz="853410" rtl="0" eaLnBrk="1" latinLnBrk="0" hangingPunct="1">
        <a:defRPr sz="16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5.bin"/><Relationship Id="rId3" Type="http://schemas.openxmlformats.org/officeDocument/2006/relationships/image" Target="../media/image2.emf"/><Relationship Id="rId7" Type="http://schemas.openxmlformats.org/officeDocument/2006/relationships/image" Target="../media/image4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4.bin"/><Relationship Id="rId11" Type="http://schemas.openxmlformats.org/officeDocument/2006/relationships/image" Target="../media/image6.emf"/><Relationship Id="rId5" Type="http://schemas.openxmlformats.org/officeDocument/2006/relationships/image" Target="../media/image3.emf"/><Relationship Id="rId10" Type="http://schemas.openxmlformats.org/officeDocument/2006/relationships/oleObject" Target="../embeddings/oleObject6.bin"/><Relationship Id="rId4" Type="http://schemas.openxmlformats.org/officeDocument/2006/relationships/oleObject" Target="../embeddings/oleObject3.bin"/><Relationship Id="rId9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990FA540-013C-48BC-B75C-8D54A362B27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11457848"/>
              </p:ext>
            </p:extLst>
          </p:nvPr>
        </p:nvGraphicFramePr>
        <p:xfrm>
          <a:off x="1004887" y="1704975"/>
          <a:ext cx="6643688" cy="2171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7092153" imgH="2318344" progId="Prism9.Document">
                  <p:embed/>
                </p:oleObj>
              </mc:Choice>
              <mc:Fallback>
                <p:oleObj name="Prism 9" r:id="rId2" imgW="7092153" imgH="2318344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990FA540-013C-48BC-B75C-8D54A362B27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04887" y="1704975"/>
                        <a:ext cx="6643688" cy="2171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60E0C5BC-920B-EE19-7831-2910B38AEFA9}"/>
              </a:ext>
            </a:extLst>
          </p:cNvPr>
          <p:cNvSpPr txBox="1"/>
          <p:nvPr/>
        </p:nvSpPr>
        <p:spPr>
          <a:xfrm>
            <a:off x="627412" y="418509"/>
            <a:ext cx="739863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	Suppl. Figure 1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dy weight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nel 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fasting blood glucose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nel 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fter 16 weeks of treatment with diet containing ertugliflozin (ERTU) or control diet (CD) without ERTU.  Data are shown as mean </a:t>
            </a:r>
            <a:r>
              <a:rPr lang="en-US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±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M; n = 9-16 mice/condition; ** = p &lt; 0.005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4615327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43B29CB9-C02E-4CCA-AAB5-6CF2273220C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39141773"/>
              </p:ext>
            </p:extLst>
          </p:nvPr>
        </p:nvGraphicFramePr>
        <p:xfrm>
          <a:off x="2754313" y="1363663"/>
          <a:ext cx="2449512" cy="2262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2" imgW="3343500" imgH="3085800" progId="Prism5.Document">
                  <p:embed/>
                </p:oleObj>
              </mc:Choice>
              <mc:Fallback>
                <p:oleObj name="Prism 5" r:id="rId2" imgW="3343500" imgH="3085800" progId="Prism5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43B29CB9-C02E-4CCA-AAB5-6CF2273220C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754313" y="1363663"/>
                        <a:ext cx="2449512" cy="2262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F3A0B26B-7D24-487A-8835-0F07F3789E2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59793144"/>
              </p:ext>
            </p:extLst>
          </p:nvPr>
        </p:nvGraphicFramePr>
        <p:xfrm>
          <a:off x="5108575" y="1363663"/>
          <a:ext cx="2452688" cy="2262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4" imgW="3346381" imgH="3085800" progId="Prism5.Document">
                  <p:embed/>
                </p:oleObj>
              </mc:Choice>
              <mc:Fallback>
                <p:oleObj name="Prism 5" r:id="rId4" imgW="3346381" imgH="3085800" progId="Prism5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F3A0B26B-7D24-487A-8835-0F07F3789E2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108575" y="1363663"/>
                        <a:ext cx="2452688" cy="2262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E47E4D1B-1BD8-45F5-B42A-C96CA524F48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04767200"/>
              </p:ext>
            </p:extLst>
          </p:nvPr>
        </p:nvGraphicFramePr>
        <p:xfrm>
          <a:off x="1108075" y="3860800"/>
          <a:ext cx="2705100" cy="2263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6" imgW="3689590" imgH="3085800" progId="Prism5.Document">
                  <p:embed/>
                </p:oleObj>
              </mc:Choice>
              <mc:Fallback>
                <p:oleObj name="Prism 5" r:id="rId6" imgW="3689590" imgH="3085800" progId="Prism5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E47E4D1B-1BD8-45F5-B42A-C96CA524F48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108075" y="3860800"/>
                        <a:ext cx="2705100" cy="2263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2AF185EC-5D4C-4D3D-A9CC-A10ADC57E5E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48688461"/>
              </p:ext>
            </p:extLst>
          </p:nvPr>
        </p:nvGraphicFramePr>
        <p:xfrm>
          <a:off x="4256088" y="3789363"/>
          <a:ext cx="2528887" cy="2262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8" imgW="3450100" imgH="3085800" progId="Prism5.Document">
                  <p:embed/>
                </p:oleObj>
              </mc:Choice>
              <mc:Fallback>
                <p:oleObj name="Prism 5" r:id="rId8" imgW="3450100" imgH="3085800" progId="Prism5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2AF185EC-5D4C-4D3D-A9CC-A10ADC57E5E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256088" y="3789363"/>
                        <a:ext cx="2528887" cy="2262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70E1F445-FB47-4C15-B45D-6CD3A6ABEC0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44706439"/>
              </p:ext>
            </p:extLst>
          </p:nvPr>
        </p:nvGraphicFramePr>
        <p:xfrm>
          <a:off x="136525" y="1363663"/>
          <a:ext cx="2644775" cy="2262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10" imgW="3607119" imgH="3085800" progId="Prism5.Document">
                  <p:embed/>
                </p:oleObj>
              </mc:Choice>
              <mc:Fallback>
                <p:oleObj name="Prism 5" r:id="rId10" imgW="3607119" imgH="3085800" progId="Prism5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70E1F445-FB47-4C15-B45D-6CD3A6ABEC0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36525" y="1363663"/>
                        <a:ext cx="2644775" cy="2262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2E0774AE-8898-6201-4C0A-AAEAB1C60D01}"/>
              </a:ext>
            </a:extLst>
          </p:cNvPr>
          <p:cNvSpPr txBox="1"/>
          <p:nvPr/>
        </p:nvSpPr>
        <p:spPr>
          <a:xfrm>
            <a:off x="346085" y="186110"/>
            <a:ext cx="7602857" cy="10508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457206" algn="just">
              <a:lnSpc>
                <a:spcPct val="107000"/>
              </a:lnSpc>
              <a:defRPr/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. </a:t>
            </a:r>
            <a:r>
              <a:rPr kumimoji="0" lang="en-US" sz="1200" b="1" i="0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0" lang="en-US" sz="1200" b="1" i="0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kumimoji="0" lang="en-US" sz="1200" i="0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chocardiographic measurements after 16 weeks of treatment with ERTU or control diet. EDD = end-diastolic dimension, ESD = end-systolic dimension, LVFS = left ventricle fractional shortening, WT CD = wild type / control diet (n= 13), WT ERTU = wild-type / ERTU (n = 10), G</a:t>
            </a:r>
            <a:r>
              <a:rPr kumimoji="0" lang="el-GR" sz="1200" i="0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kumimoji="0" lang="en-US" sz="1200" i="0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 CD = Gq / control diet (n = 15), G</a:t>
            </a:r>
            <a:r>
              <a:rPr kumimoji="0" lang="el-GR" sz="1200" i="0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kumimoji="0" lang="en-US" sz="1200" i="0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 ERTU = G</a:t>
            </a:r>
            <a:r>
              <a:rPr kumimoji="0" lang="el-GR" sz="1200" i="0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kumimoji="0" lang="en-US" sz="1200" i="0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 / ERTU (n=12). </a:t>
            </a:r>
            <a:r>
              <a:rPr kumimoji="0" lang="en-US" sz="1200" b="1" i="0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kumimoji="0" lang="en-US" sz="1200" i="0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= P&lt;0.05 vs WT CD, </a:t>
            </a:r>
            <a:r>
              <a:rPr kumimoji="0" lang="en-US" sz="1200" i="0" strike="noStrike" kern="1200" cap="none" spc="0" normalizeH="0" baseline="300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#</a:t>
            </a:r>
            <a:r>
              <a:rPr kumimoji="0" lang="en-US" sz="1200" i="0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= P&lt;0.05 vs G</a:t>
            </a:r>
            <a:r>
              <a:rPr kumimoji="0" lang="el-GR" sz="1200" i="0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kumimoji="0" lang="en-US" sz="1200" i="0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 CD.</a:t>
            </a:r>
          </a:p>
          <a:p>
            <a:pPr marL="0" marR="0" lvl="0" indent="457206" defTabSz="4572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100" i="0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highlight>
                <a:srgbClr val="FFFF00"/>
              </a:highlight>
              <a:uLnTx/>
              <a:uFillTx/>
              <a:latin typeface="Arial" panose="020B06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845108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52</TotalTime>
  <Words>170</Words>
  <Application>Microsoft Office PowerPoint</Application>
  <PresentationFormat>Custom</PresentationFormat>
  <Paragraphs>2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rism 9</vt:lpstr>
      <vt:lpstr>Prism 5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Gq ERTU Storyboard</dc:title>
  <dc:creator>Jori Chambers</dc:creator>
  <cp:lastModifiedBy>Colucci, Wilson</cp:lastModifiedBy>
  <cp:revision>154</cp:revision>
  <cp:lastPrinted>2023-01-24T20:15:07Z</cp:lastPrinted>
  <dcterms:created xsi:type="dcterms:W3CDTF">2021-09-20T21:03:05Z</dcterms:created>
  <dcterms:modified xsi:type="dcterms:W3CDTF">2025-03-27T17:19:20Z</dcterms:modified>
</cp:coreProperties>
</file>